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7714A8-3D9B-4102-9A1F-2154A39A71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FC040-8226-4C0D-8F15-541DA87B25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9AC59-AE6A-41F5-AC4F-9AE7D313CD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D832F-2847-4FD6-ACD9-1D28391D11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4A4A5B-66F2-4833-B1E2-53758C50BF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776CC5-3501-4BF1-9622-CDB28F4794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5A6A5-6BE0-459B-B22D-C7558439CA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77EA2-0EC1-4ABB-B7B9-568119DAFD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648C0F-5CBB-4ED8-8738-CBB219AE89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DF7A6E-6BD2-4562-B358-F3E596957B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D552A-312F-49AF-BC98-001C9CB374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540B5-8B3A-42EA-99C5-4124DA2523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A7C5E6-D0FA-41FF-BABE-9F0B695D1C2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152640" y="152280"/>
            <a:ext cx="263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23"/>
          <p:cNvSpPr/>
          <p:nvPr/>
        </p:nvSpPr>
        <p:spPr>
          <a:xfrm>
            <a:off x="1432440" y="2254320"/>
            <a:ext cx="54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A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25"/>
          <p:cNvSpPr/>
          <p:nvPr/>
        </p:nvSpPr>
        <p:spPr>
          <a:xfrm>
            <a:off x="1441800" y="2787480"/>
            <a:ext cx="537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AX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31"/>
          <p:cNvSpPr/>
          <p:nvPr/>
        </p:nvSpPr>
        <p:spPr>
          <a:xfrm>
            <a:off x="1501560" y="324468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I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50"/>
          <p:cNvSpPr/>
          <p:nvPr/>
        </p:nvSpPr>
        <p:spPr>
          <a:xfrm>
            <a:off x="1213920" y="5454720"/>
            <a:ext cx="76284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CL-X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71"/>
          <p:cNvSpPr/>
          <p:nvPr/>
        </p:nvSpPr>
        <p:spPr>
          <a:xfrm>
            <a:off x="1482120" y="3854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IM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75"/>
          <p:cNvSpPr/>
          <p:nvPr/>
        </p:nvSpPr>
        <p:spPr>
          <a:xfrm>
            <a:off x="1290960" y="4522680"/>
            <a:ext cx="69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UM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51"/>
          <p:cNvSpPr/>
          <p:nvPr/>
        </p:nvSpPr>
        <p:spPr>
          <a:xfrm rot="18900000">
            <a:off x="2026800" y="1415520"/>
            <a:ext cx="48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52"/>
          <p:cNvSpPr/>
          <p:nvPr/>
        </p:nvSpPr>
        <p:spPr>
          <a:xfrm rot="18900000">
            <a:off x="2298600" y="128700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53"/>
          <p:cNvSpPr/>
          <p:nvPr/>
        </p:nvSpPr>
        <p:spPr>
          <a:xfrm rot="18900000">
            <a:off x="2784240" y="1415160"/>
            <a:ext cx="48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54"/>
          <p:cNvSpPr/>
          <p:nvPr/>
        </p:nvSpPr>
        <p:spPr>
          <a:xfrm rot="18900000">
            <a:off x="3117960" y="128664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55"/>
          <p:cNvSpPr/>
          <p:nvPr/>
        </p:nvSpPr>
        <p:spPr>
          <a:xfrm rot="18900000">
            <a:off x="3582720" y="1415160"/>
            <a:ext cx="48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56"/>
          <p:cNvSpPr/>
          <p:nvPr/>
        </p:nvSpPr>
        <p:spPr>
          <a:xfrm rot="18900000">
            <a:off x="3898800" y="128700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57"/>
          <p:cNvSpPr/>
          <p:nvPr/>
        </p:nvSpPr>
        <p:spPr>
          <a:xfrm rot="18900000">
            <a:off x="4384440" y="1415160"/>
            <a:ext cx="48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58"/>
          <p:cNvSpPr/>
          <p:nvPr/>
        </p:nvSpPr>
        <p:spPr>
          <a:xfrm rot="18900000">
            <a:off x="4721400" y="128664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60"/>
          <p:cNvSpPr/>
          <p:nvPr/>
        </p:nvSpPr>
        <p:spPr>
          <a:xfrm>
            <a:off x="2066760" y="1143000"/>
            <a:ext cx="685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64"/>
          <p:cNvSpPr/>
          <p:nvPr/>
        </p:nvSpPr>
        <p:spPr>
          <a:xfrm>
            <a:off x="2188080" y="7621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65"/>
          <p:cNvSpPr/>
          <p:nvPr/>
        </p:nvSpPr>
        <p:spPr>
          <a:xfrm>
            <a:off x="2905920" y="7621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8h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66"/>
          <p:cNvSpPr/>
          <p:nvPr/>
        </p:nvSpPr>
        <p:spPr>
          <a:xfrm>
            <a:off x="3744000" y="7621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2h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67"/>
          <p:cNvSpPr/>
          <p:nvPr/>
        </p:nvSpPr>
        <p:spPr>
          <a:xfrm>
            <a:off x="4550400" y="76212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6h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60"/>
          <p:cNvSpPr/>
          <p:nvPr/>
        </p:nvSpPr>
        <p:spPr>
          <a:xfrm>
            <a:off x="2847960" y="1143000"/>
            <a:ext cx="685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60"/>
          <p:cNvSpPr/>
          <p:nvPr/>
        </p:nvSpPr>
        <p:spPr>
          <a:xfrm>
            <a:off x="3657600" y="1143000"/>
            <a:ext cx="685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60"/>
          <p:cNvSpPr/>
          <p:nvPr/>
        </p:nvSpPr>
        <p:spPr>
          <a:xfrm>
            <a:off x="4429080" y="1143000"/>
            <a:ext cx="685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4" name="Object 587"/>
          <p:cNvGraphicFramePr/>
          <p:nvPr/>
        </p:nvGraphicFramePr>
        <p:xfrm>
          <a:off x="2001960" y="4921200"/>
          <a:ext cx="3243240" cy="3808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5" name="Object 58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001960" y="4921200"/>
                    <a:ext cx="3243240" cy="3808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66" name="TextBox 75"/>
          <p:cNvSpPr/>
          <p:nvPr/>
        </p:nvSpPr>
        <p:spPr>
          <a:xfrm>
            <a:off x="1422360" y="4921200"/>
            <a:ext cx="55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OK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7" name="Object 588"/>
          <p:cNvGraphicFramePr/>
          <p:nvPr/>
        </p:nvGraphicFramePr>
        <p:xfrm>
          <a:off x="2001960" y="2254320"/>
          <a:ext cx="3243240" cy="3477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8" name="Object 58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001960" y="2254320"/>
                    <a:ext cx="3243240" cy="3477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69" name="Object 589"/>
          <p:cNvGraphicFramePr/>
          <p:nvPr/>
        </p:nvGraphicFramePr>
        <p:xfrm>
          <a:off x="2001960" y="2711520"/>
          <a:ext cx="3243240" cy="3808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70" name="Object 589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001960" y="2711520"/>
                    <a:ext cx="3243240" cy="3808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71" name="Object 590"/>
          <p:cNvGraphicFramePr/>
          <p:nvPr/>
        </p:nvGraphicFramePr>
        <p:xfrm>
          <a:off x="2001960" y="4446720"/>
          <a:ext cx="3243240" cy="3981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72" name="Object 590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001960" y="4446720"/>
                    <a:ext cx="3243240" cy="3981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73" name="Object 591"/>
          <p:cNvGraphicFramePr/>
          <p:nvPr/>
        </p:nvGraphicFramePr>
        <p:xfrm>
          <a:off x="2001960" y="3168720"/>
          <a:ext cx="3243240" cy="3776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74" name="Object 591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2001960" y="3168720"/>
                    <a:ext cx="3243240" cy="3776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75" name="Object 592"/>
          <p:cNvGraphicFramePr/>
          <p:nvPr/>
        </p:nvGraphicFramePr>
        <p:xfrm>
          <a:off x="2001960" y="5378400"/>
          <a:ext cx="3243240" cy="38088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76" name="Object 592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001960" y="5378400"/>
                    <a:ext cx="3243240" cy="3808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77" name="AutoShape 48"/>
          <p:cNvSpPr/>
          <p:nvPr/>
        </p:nvSpPr>
        <p:spPr>
          <a:xfrm>
            <a:off x="747720" y="1828800"/>
            <a:ext cx="380880" cy="3397320"/>
          </a:xfrm>
          <a:custGeom>
            <a:avLst/>
            <a:gdLst>
              <a:gd name="textAreaLeft" fmla="*/ 243360 w 380880"/>
              <a:gd name="textAreaRight" fmla="*/ 381240 w 380880"/>
              <a:gd name="textAreaTop" fmla="*/ 88560 h 3397320"/>
              <a:gd name="textAreaBottom" fmla="*/ 3308760 h 33973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9"/>
          <p:cNvSpPr/>
          <p:nvPr/>
        </p:nvSpPr>
        <p:spPr>
          <a:xfrm rot="16200000">
            <a:off x="-304200" y="3400560"/>
            <a:ext cx="158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o-apoptosis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50"/>
          <p:cNvSpPr/>
          <p:nvPr/>
        </p:nvSpPr>
        <p:spPr>
          <a:xfrm>
            <a:off x="1266120" y="583560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CL-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0" name="Object 593"/>
          <p:cNvGraphicFramePr/>
          <p:nvPr/>
        </p:nvGraphicFramePr>
        <p:xfrm>
          <a:off x="2001960" y="5835600"/>
          <a:ext cx="3243240" cy="28260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81" name="Object 593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2001960" y="5835600"/>
                    <a:ext cx="3243240" cy="28260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82" name="Object 594"/>
          <p:cNvGraphicFramePr/>
          <p:nvPr/>
        </p:nvGraphicFramePr>
        <p:xfrm>
          <a:off x="2001960" y="3625920"/>
          <a:ext cx="3243240" cy="7160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83" name="Object 594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2001960" y="3625920"/>
                    <a:ext cx="3243240" cy="7160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84" name="Text Box 53"/>
          <p:cNvSpPr/>
          <p:nvPr/>
        </p:nvSpPr>
        <p:spPr>
          <a:xfrm>
            <a:off x="5426280" y="3625920"/>
            <a:ext cx="9579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im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EL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22kDa)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54"/>
          <p:cNvSpPr/>
          <p:nvPr/>
        </p:nvSpPr>
        <p:spPr>
          <a:xfrm flipH="1">
            <a:off x="5333760" y="377820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55"/>
          <p:cNvSpPr/>
          <p:nvPr/>
        </p:nvSpPr>
        <p:spPr>
          <a:xfrm flipH="1">
            <a:off x="5333760" y="404496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56"/>
          <p:cNvSpPr/>
          <p:nvPr/>
        </p:nvSpPr>
        <p:spPr>
          <a:xfrm flipH="1">
            <a:off x="5333760" y="415908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57"/>
          <p:cNvSpPr/>
          <p:nvPr/>
        </p:nvSpPr>
        <p:spPr>
          <a:xfrm>
            <a:off x="5422320" y="3854520"/>
            <a:ext cx="90900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im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L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15kDa)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58"/>
          <p:cNvSpPr/>
          <p:nvPr/>
        </p:nvSpPr>
        <p:spPr>
          <a:xfrm>
            <a:off x="5440680" y="4035600"/>
            <a:ext cx="9169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im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S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12kDa)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AutoShape 59"/>
          <p:cNvSpPr/>
          <p:nvPr/>
        </p:nvSpPr>
        <p:spPr>
          <a:xfrm>
            <a:off x="762120" y="5378400"/>
            <a:ext cx="380880" cy="762120"/>
          </a:xfrm>
          <a:custGeom>
            <a:avLst/>
            <a:gdLst>
              <a:gd name="textAreaLeft" fmla="*/ 243360 w 380880"/>
              <a:gd name="textAreaRight" fmla="*/ 381240 w 380880"/>
              <a:gd name="textAreaTop" fmla="*/ 19800 h 762120"/>
              <a:gd name="textAreaBottom" fmla="*/ 742320 h 7621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60"/>
          <p:cNvSpPr/>
          <p:nvPr/>
        </p:nvSpPr>
        <p:spPr>
          <a:xfrm rot="16200000">
            <a:off x="-321840" y="5597280"/>
            <a:ext cx="1625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nti-apoptosis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2" name="Object 595"/>
          <p:cNvGraphicFramePr/>
          <p:nvPr/>
        </p:nvGraphicFramePr>
        <p:xfrm>
          <a:off x="2001960" y="1800360"/>
          <a:ext cx="3238200" cy="37764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93" name="Object 595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2001960" y="1800360"/>
                    <a:ext cx="3238200" cy="3776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94" name="TextBox 23"/>
          <p:cNvSpPr/>
          <p:nvPr/>
        </p:nvSpPr>
        <p:spPr>
          <a:xfrm>
            <a:off x="1295280" y="1828800"/>
            <a:ext cx="70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-BA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46"/>
          <p:cNvSpPr/>
          <p:nvPr/>
        </p:nvSpPr>
        <p:spPr>
          <a:xfrm>
            <a:off x="5288400" y="18874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Straight Connector 47"/>
          <p:cNvSpPr/>
          <p:nvPr/>
        </p:nvSpPr>
        <p:spPr>
          <a:xfrm>
            <a:off x="5273640" y="20113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48"/>
          <p:cNvSpPr/>
          <p:nvPr/>
        </p:nvSpPr>
        <p:spPr>
          <a:xfrm>
            <a:off x="5291640" y="23162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Straight Connector 49"/>
          <p:cNvSpPr/>
          <p:nvPr/>
        </p:nvSpPr>
        <p:spPr>
          <a:xfrm>
            <a:off x="5276880" y="244008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50"/>
          <p:cNvSpPr/>
          <p:nvPr/>
        </p:nvSpPr>
        <p:spPr>
          <a:xfrm>
            <a:off x="5291640" y="27352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Straight Connector 51"/>
          <p:cNvSpPr/>
          <p:nvPr/>
        </p:nvSpPr>
        <p:spPr>
          <a:xfrm>
            <a:off x="5276880" y="28591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52"/>
          <p:cNvSpPr/>
          <p:nvPr/>
        </p:nvSpPr>
        <p:spPr>
          <a:xfrm>
            <a:off x="5291640" y="32209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Straight Connector 53"/>
          <p:cNvSpPr/>
          <p:nvPr/>
        </p:nvSpPr>
        <p:spPr>
          <a:xfrm>
            <a:off x="5276880" y="33447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54"/>
          <p:cNvSpPr/>
          <p:nvPr/>
        </p:nvSpPr>
        <p:spPr>
          <a:xfrm>
            <a:off x="5291640" y="45543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Straight Connector 55"/>
          <p:cNvSpPr/>
          <p:nvPr/>
        </p:nvSpPr>
        <p:spPr>
          <a:xfrm>
            <a:off x="5276880" y="46782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56"/>
          <p:cNvSpPr/>
          <p:nvPr/>
        </p:nvSpPr>
        <p:spPr>
          <a:xfrm>
            <a:off x="5291640" y="48769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Straight Connector 57"/>
          <p:cNvSpPr/>
          <p:nvPr/>
        </p:nvSpPr>
        <p:spPr>
          <a:xfrm>
            <a:off x="5276880" y="50007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58"/>
          <p:cNvSpPr/>
          <p:nvPr/>
        </p:nvSpPr>
        <p:spPr>
          <a:xfrm>
            <a:off x="5291640" y="53164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6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Straight Connector 59"/>
          <p:cNvSpPr/>
          <p:nvPr/>
        </p:nvSpPr>
        <p:spPr>
          <a:xfrm>
            <a:off x="5276880" y="54403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61"/>
          <p:cNvSpPr/>
          <p:nvPr/>
        </p:nvSpPr>
        <p:spPr>
          <a:xfrm>
            <a:off x="5291640" y="59259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Straight Connector 62"/>
          <p:cNvSpPr/>
          <p:nvPr/>
        </p:nvSpPr>
        <p:spPr>
          <a:xfrm>
            <a:off x="5276880" y="60498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01T13:55:26Z</dcterms:created>
  <dc:creator>Chee-Onn Leong</dc:creator>
  <dc:description/>
  <dc:language>en-US</dc:language>
  <cp:lastModifiedBy>L.Latha</cp:lastModifiedBy>
  <dcterms:modified xsi:type="dcterms:W3CDTF">2015-07-13T10:45:27Z</dcterms:modified>
  <cp:revision>287</cp:revision>
  <dc:subject/>
  <dc:title>Slide 1</dc:title>
</cp:coreProperties>
</file>